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2" r:id="rId2"/>
    <p:sldId id="263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A408B73-5CDA-46B3-8D34-8F1334386B55}" v="2" dt="2026-04-03T15:56:11.77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35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cholas Wallace" userId="7a92b5d4-21f1-4929-81f4-746d288668f5" providerId="ADAL" clId="{DA408B73-5CDA-46B3-8D34-8F1334386B55}"/>
    <pc:docChg chg="undo redo custSel addSld delSld modSld">
      <pc:chgData name="Nicholas Wallace" userId="7a92b5d4-21f1-4929-81f4-746d288668f5" providerId="ADAL" clId="{DA408B73-5CDA-46B3-8D34-8F1334386B55}" dt="2026-04-03T16:01:01.418" v="51" actId="6549"/>
      <pc:docMkLst>
        <pc:docMk/>
      </pc:docMkLst>
      <pc:sldChg chg="addSp modSp add mod">
        <pc:chgData name="Nicholas Wallace" userId="7a92b5d4-21f1-4929-81f4-746d288668f5" providerId="ADAL" clId="{DA408B73-5CDA-46B3-8D34-8F1334386B55}" dt="2026-04-03T15:57:00.990" v="22" actId="20577"/>
        <pc:sldMkLst>
          <pc:docMk/>
          <pc:sldMk cId="4070491949" sldId="262"/>
        </pc:sldMkLst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3" creationId="{3C2BF7E9-E61D-EFAC-0AA0-EF86DA53E24E}"/>
          </ac:spMkLst>
        </pc:spChg>
        <pc:spChg chg="mod">
          <ac:chgData name="Nicholas Wallace" userId="7a92b5d4-21f1-4929-81f4-746d288668f5" providerId="ADAL" clId="{DA408B73-5CDA-46B3-8D34-8F1334386B55}" dt="2026-04-03T15:55:54.647" v="10" actId="1076"/>
          <ac:spMkLst>
            <pc:docMk/>
            <pc:sldMk cId="4070491949" sldId="262"/>
            <ac:spMk id="6" creationId="{55A247B6-B14F-48FE-AE3B-C4CD2ADAE853}"/>
          </ac:spMkLst>
        </pc:spChg>
        <pc:spChg chg="mod">
          <ac:chgData name="Nicholas Wallace" userId="7a92b5d4-21f1-4929-81f4-746d288668f5" providerId="ADAL" clId="{DA408B73-5CDA-46B3-8D34-8F1334386B55}" dt="2026-04-03T15:55:54.647" v="10" actId="1076"/>
          <ac:spMkLst>
            <pc:docMk/>
            <pc:sldMk cId="4070491949" sldId="262"/>
            <ac:spMk id="7" creationId="{4175A3CD-30C6-4EAC-A8BC-ED341382C4D9}"/>
          </ac:spMkLst>
        </pc:spChg>
        <pc:spChg chg="mod">
          <ac:chgData name="Nicholas Wallace" userId="7a92b5d4-21f1-4929-81f4-746d288668f5" providerId="ADAL" clId="{DA408B73-5CDA-46B3-8D34-8F1334386B55}" dt="2026-04-03T15:55:54.647" v="10" actId="1076"/>
          <ac:spMkLst>
            <pc:docMk/>
            <pc:sldMk cId="4070491949" sldId="262"/>
            <ac:spMk id="9" creationId="{F57EA098-48D5-47AD-9B0B-987B3C4532C7}"/>
          </ac:spMkLst>
        </pc:spChg>
        <pc:spChg chg="mod">
          <ac:chgData name="Nicholas Wallace" userId="7a92b5d4-21f1-4929-81f4-746d288668f5" providerId="ADAL" clId="{DA408B73-5CDA-46B3-8D34-8F1334386B55}" dt="2026-04-03T15:55:54.647" v="10" actId="1076"/>
          <ac:spMkLst>
            <pc:docMk/>
            <pc:sldMk cId="4070491949" sldId="262"/>
            <ac:spMk id="10" creationId="{EFB62884-AF70-4D6E-BAB4-B7009B4C3C60}"/>
          </ac:spMkLst>
        </pc:spChg>
        <pc:spChg chg="mod">
          <ac:chgData name="Nicholas Wallace" userId="7a92b5d4-21f1-4929-81f4-746d288668f5" providerId="ADAL" clId="{DA408B73-5CDA-46B3-8D34-8F1334386B55}" dt="2026-04-03T15:56:16.600" v="13" actId="6549"/>
          <ac:spMkLst>
            <pc:docMk/>
            <pc:sldMk cId="4070491949" sldId="262"/>
            <ac:spMk id="14" creationId="{A9EFF0AD-FEAD-4F40-B704-1C59817B0E45}"/>
          </ac:spMkLst>
        </pc:spChg>
        <pc:spChg chg="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15" creationId="{11AFFB5F-4D3C-505D-76F6-B9279BA5C8C9}"/>
          </ac:spMkLst>
        </pc:spChg>
        <pc:spChg chg="mod">
          <ac:chgData name="Nicholas Wallace" userId="7a92b5d4-21f1-4929-81f4-746d288668f5" providerId="ADAL" clId="{DA408B73-5CDA-46B3-8D34-8F1334386B55}" dt="2026-04-03T15:56:28.382" v="15" actId="20577"/>
          <ac:spMkLst>
            <pc:docMk/>
            <pc:sldMk cId="4070491949" sldId="262"/>
            <ac:spMk id="16" creationId="{6F383EFD-8AF4-4BCE-886F-44E7A1817ECC}"/>
          </ac:spMkLst>
        </pc:spChg>
        <pc:spChg chg="mod">
          <ac:chgData name="Nicholas Wallace" userId="7a92b5d4-21f1-4929-81f4-746d288668f5" providerId="ADAL" clId="{DA408B73-5CDA-46B3-8D34-8F1334386B55}" dt="2026-04-03T15:56:53.585" v="20" actId="20577"/>
          <ac:spMkLst>
            <pc:docMk/>
            <pc:sldMk cId="4070491949" sldId="262"/>
            <ac:spMk id="17" creationId="{134D3513-E3E1-43D0-B4E2-E3FE937709EB}"/>
          </ac:spMkLst>
        </pc:spChg>
        <pc:spChg chg="mod">
          <ac:chgData name="Nicholas Wallace" userId="7a92b5d4-21f1-4929-81f4-746d288668f5" providerId="ADAL" clId="{DA408B73-5CDA-46B3-8D34-8F1334386B55}" dt="2026-04-03T15:56:46.066" v="18" actId="1037"/>
          <ac:spMkLst>
            <pc:docMk/>
            <pc:sldMk cId="4070491949" sldId="262"/>
            <ac:spMk id="18" creationId="{E1A4D9E4-2F35-4454-B714-E80B178D6074}"/>
          </ac:spMkLst>
        </pc:spChg>
        <pc:spChg chg="mod">
          <ac:chgData name="Nicholas Wallace" userId="7a92b5d4-21f1-4929-81f4-746d288668f5" providerId="ADAL" clId="{DA408B73-5CDA-46B3-8D34-8F1334386B55}" dt="2026-04-03T15:57:00.990" v="22" actId="20577"/>
          <ac:spMkLst>
            <pc:docMk/>
            <pc:sldMk cId="4070491949" sldId="262"/>
            <ac:spMk id="20" creationId="{3FDD71EA-D1F4-B2F2-5875-42D19C29E19C}"/>
          </ac:spMkLst>
        </pc:spChg>
        <pc:spChg chg="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28" creationId="{0820BE1A-CE5B-5177-9C27-7287F216DC9F}"/>
          </ac:spMkLst>
        </pc:spChg>
        <pc:spChg chg="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29" creationId="{4C58AC7C-E8FC-00BD-C84A-68C32FB54B1A}"/>
          </ac:spMkLst>
        </pc:spChg>
        <pc:spChg chg="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30" creationId="{0B0BE5FF-CE1D-F33F-862D-819AF001DDB9}"/>
          </ac:spMkLst>
        </pc:spChg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41" creationId="{C1EDA770-B72B-2FD1-2DC7-B6F09D534FF1}"/>
          </ac:spMkLst>
        </pc:spChg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43" creationId="{DB7536DF-1088-9C1B-EC76-00A09DF44AF1}"/>
          </ac:spMkLst>
        </pc:spChg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45" creationId="{63D7F391-C9D9-74AF-55B5-D9158EBB60D3}"/>
          </ac:spMkLst>
        </pc:spChg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46" creationId="{B8C0C829-0E1F-6BFE-C3B0-D0C667907C62}"/>
          </ac:spMkLst>
        </pc:spChg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47" creationId="{67784783-4890-F51D-DF72-8BA95CBD6FFE}"/>
          </ac:spMkLst>
        </pc:spChg>
        <pc:spChg chg="add mod">
          <ac:chgData name="Nicholas Wallace" userId="7a92b5d4-21f1-4929-81f4-746d288668f5" providerId="ADAL" clId="{DA408B73-5CDA-46B3-8D34-8F1334386B55}" dt="2026-04-03T15:56:11.776" v="11"/>
          <ac:spMkLst>
            <pc:docMk/>
            <pc:sldMk cId="4070491949" sldId="262"/>
            <ac:spMk id="48" creationId="{1780D38A-4636-2CEE-9470-84C0E57E3778}"/>
          </ac:spMkLst>
        </pc:spChg>
        <pc:grpChg chg="add mod">
          <ac:chgData name="Nicholas Wallace" userId="7a92b5d4-21f1-4929-81f4-746d288668f5" providerId="ADAL" clId="{DA408B73-5CDA-46B3-8D34-8F1334386B55}" dt="2026-04-03T15:56:11.776" v="11"/>
          <ac:grpSpMkLst>
            <pc:docMk/>
            <pc:sldMk cId="4070491949" sldId="262"/>
            <ac:grpSpMk id="5" creationId="{572D7E13-95F8-1585-5D06-D1436C245B77}"/>
          </ac:grpSpMkLst>
        </pc:grpChg>
        <pc:grpChg chg="mod">
          <ac:chgData name="Nicholas Wallace" userId="7a92b5d4-21f1-4929-81f4-746d288668f5" providerId="ADAL" clId="{DA408B73-5CDA-46B3-8D34-8F1334386B55}" dt="2026-04-03T15:55:54.647" v="10" actId="1076"/>
          <ac:grpSpMkLst>
            <pc:docMk/>
            <pc:sldMk cId="4070491949" sldId="262"/>
            <ac:grpSpMk id="8" creationId="{81B45433-1E91-0D39-3974-D2503AE82DDB}"/>
          </ac:grpSpMkLst>
        </pc:grpChg>
        <pc:grpChg chg="mod">
          <ac:chgData name="Nicholas Wallace" userId="7a92b5d4-21f1-4929-81f4-746d288668f5" providerId="ADAL" clId="{DA408B73-5CDA-46B3-8D34-8F1334386B55}" dt="2026-04-03T15:55:54.647" v="10" actId="1076"/>
          <ac:grpSpMkLst>
            <pc:docMk/>
            <pc:sldMk cId="4070491949" sldId="262"/>
            <ac:grpSpMk id="27" creationId="{F5524192-0D2D-B12F-ABB5-D11DD92496D9}"/>
          </ac:grpSpMkLst>
        </pc:grpChg>
        <pc:grpChg chg="add mod">
          <ac:chgData name="Nicholas Wallace" userId="7a92b5d4-21f1-4929-81f4-746d288668f5" providerId="ADAL" clId="{DA408B73-5CDA-46B3-8D34-8F1334386B55}" dt="2026-04-03T15:56:11.776" v="11"/>
          <ac:grpSpMkLst>
            <pc:docMk/>
            <pc:sldMk cId="4070491949" sldId="262"/>
            <ac:grpSpMk id="39" creationId="{7AAD6003-A818-B45D-7FFB-77348215B912}"/>
          </ac:grpSpMkLst>
        </pc:grpChg>
        <pc:picChg chg="mod">
          <ac:chgData name="Nicholas Wallace" userId="7a92b5d4-21f1-4929-81f4-746d288668f5" providerId="ADAL" clId="{DA408B73-5CDA-46B3-8D34-8F1334386B55}" dt="2026-04-03T15:55:54.647" v="10" actId="1076"/>
          <ac:picMkLst>
            <pc:docMk/>
            <pc:sldMk cId="4070491949" sldId="262"/>
            <ac:picMk id="12" creationId="{71208C79-240B-48E3-AC53-343E1486C0F2}"/>
          </ac:picMkLst>
        </pc:picChg>
        <pc:picChg chg="mod">
          <ac:chgData name="Nicholas Wallace" userId="7a92b5d4-21f1-4929-81f4-746d288668f5" providerId="ADAL" clId="{DA408B73-5CDA-46B3-8D34-8F1334386B55}" dt="2026-04-03T15:55:54.647" v="10" actId="1076"/>
          <ac:picMkLst>
            <pc:docMk/>
            <pc:sldMk cId="4070491949" sldId="262"/>
            <ac:picMk id="13" creationId="{A1450933-EAE2-4268-96CB-D390FC8B2F21}"/>
          </ac:picMkLst>
        </pc:picChg>
        <pc:picChg chg="mod">
          <ac:chgData name="Nicholas Wallace" userId="7a92b5d4-21f1-4929-81f4-746d288668f5" providerId="ADAL" clId="{DA408B73-5CDA-46B3-8D34-8F1334386B55}" dt="2026-04-03T15:55:54.647" v="10" actId="1076"/>
          <ac:picMkLst>
            <pc:docMk/>
            <pc:sldMk cId="4070491949" sldId="262"/>
            <ac:picMk id="19" creationId="{B32737BD-330E-1229-BE41-BB575BE16D5D}"/>
          </ac:picMkLst>
        </pc:picChg>
        <pc:picChg chg="mod">
          <ac:chgData name="Nicholas Wallace" userId="7a92b5d4-21f1-4929-81f4-746d288668f5" providerId="ADAL" clId="{DA408B73-5CDA-46B3-8D34-8F1334386B55}" dt="2026-04-03T15:56:11.776" v="11"/>
          <ac:picMkLst>
            <pc:docMk/>
            <pc:sldMk cId="4070491949" sldId="262"/>
            <ac:picMk id="36" creationId="{4A242445-5604-1FCF-08A1-2B3BF044D76B}"/>
          </ac:picMkLst>
        </pc:picChg>
        <pc:picChg chg="add mod">
          <ac:chgData name="Nicholas Wallace" userId="7a92b5d4-21f1-4929-81f4-746d288668f5" providerId="ADAL" clId="{DA408B73-5CDA-46B3-8D34-8F1334386B55}" dt="2026-04-03T15:56:11.776" v="11"/>
          <ac:picMkLst>
            <pc:docMk/>
            <pc:sldMk cId="4070491949" sldId="262"/>
            <ac:picMk id="37" creationId="{CD5371F7-3DBD-AD97-9700-BF6C5E11F3F9}"/>
          </ac:picMkLst>
        </pc:picChg>
        <pc:picChg chg="mod">
          <ac:chgData name="Nicholas Wallace" userId="7a92b5d4-21f1-4929-81f4-746d288668f5" providerId="ADAL" clId="{DA408B73-5CDA-46B3-8D34-8F1334386B55}" dt="2026-04-03T15:56:11.776" v="11"/>
          <ac:picMkLst>
            <pc:docMk/>
            <pc:sldMk cId="4070491949" sldId="262"/>
            <ac:picMk id="38" creationId="{77375DE6-B793-A307-1B0C-F55C811725E2}"/>
          </ac:picMkLst>
        </pc:picChg>
      </pc:sldChg>
      <pc:sldChg chg="modSp new mod">
        <pc:chgData name="Nicholas Wallace" userId="7a92b5d4-21f1-4929-81f4-746d288668f5" providerId="ADAL" clId="{DA408B73-5CDA-46B3-8D34-8F1334386B55}" dt="2026-04-03T16:01:01.418" v="51" actId="6549"/>
        <pc:sldMkLst>
          <pc:docMk/>
          <pc:sldMk cId="1632795120" sldId="263"/>
        </pc:sldMkLst>
        <pc:spChg chg="mod">
          <ac:chgData name="Nicholas Wallace" userId="7a92b5d4-21f1-4929-81f4-746d288668f5" providerId="ADAL" clId="{DA408B73-5CDA-46B3-8D34-8F1334386B55}" dt="2026-03-31T21:53:57.786" v="8" actId="20577"/>
          <ac:spMkLst>
            <pc:docMk/>
            <pc:sldMk cId="1632795120" sldId="263"/>
            <ac:spMk id="2" creationId="{286637B4-2A10-C83C-2390-C63C847BBD0B}"/>
          </ac:spMkLst>
        </pc:spChg>
        <pc:spChg chg="mod">
          <ac:chgData name="Nicholas Wallace" userId="7a92b5d4-21f1-4929-81f4-746d288668f5" providerId="ADAL" clId="{DA408B73-5CDA-46B3-8D34-8F1334386B55}" dt="2026-04-03T16:01:01.418" v="51" actId="6549"/>
          <ac:spMkLst>
            <pc:docMk/>
            <pc:sldMk cId="1632795120" sldId="263"/>
            <ac:spMk id="3" creationId="{445869B9-D278-6FEE-AF88-42F4C27CC553}"/>
          </ac:spMkLst>
        </pc:spChg>
      </pc:sldChg>
      <pc:sldChg chg="del">
        <pc:chgData name="Nicholas Wallace" userId="7a92b5d4-21f1-4929-81f4-746d288668f5" providerId="ADAL" clId="{DA408B73-5CDA-46B3-8D34-8F1334386B55}" dt="2026-03-31T21:47:27.412" v="1" actId="47"/>
        <pc:sldMkLst>
          <pc:docMk/>
          <pc:sldMk cId="948149050" sldId="2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8E9699-3A4E-402F-B7EE-D46DA7B4DA7D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49543E-A5E2-4F4A-ACBD-15EE0CD5ED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429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2549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3987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582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10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397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06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03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3756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5981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02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7054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F67359F-9A48-4A05-BE6A-A9FF163E3EA8}" type="datetimeFigureOut">
              <a:rPr lang="en-US" smtClean="0"/>
              <a:t>4/3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FD36EC-294F-40D4-9866-F88B270317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986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084BE-2F94-4058-A816-C804F3D7B6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6858000" cy="745629"/>
          </a:xfrm>
        </p:spPr>
        <p:txBody>
          <a:bodyPr>
            <a:normAutofit/>
          </a:bodyPr>
          <a:lstStyle/>
          <a:p>
            <a:r>
              <a:rPr lang="en-US" dirty="0"/>
              <a:t>Supplemental Figure 1: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A1450933-EAE2-4268-96CB-D390FC8B2F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5871" r="50674"/>
          <a:stretch/>
        </p:blipFill>
        <p:spPr>
          <a:xfrm>
            <a:off x="218554" y="6706362"/>
            <a:ext cx="3258653" cy="231115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1208C79-240B-48E3-AC53-343E1486C0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741" t="36545" b="33659"/>
          <a:stretch/>
        </p:blipFill>
        <p:spPr>
          <a:xfrm>
            <a:off x="3506002" y="6797587"/>
            <a:ext cx="3351998" cy="20783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5A247B6-B14F-48FE-AE3B-C4CD2ADAE853}"/>
              </a:ext>
            </a:extLst>
          </p:cNvPr>
          <p:cNvSpPr txBox="1"/>
          <p:nvPr/>
        </p:nvSpPr>
        <p:spPr>
          <a:xfrm>
            <a:off x="1410113" y="3831729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HFK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175A3CD-30C6-4EAC-A8BC-ED341382C4D9}"/>
              </a:ext>
            </a:extLst>
          </p:cNvPr>
          <p:cNvSpPr txBox="1"/>
          <p:nvPr/>
        </p:nvSpPr>
        <p:spPr>
          <a:xfrm>
            <a:off x="5264887" y="391664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HeL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57EA098-48D5-47AD-9B0B-987B3C4532C7}"/>
              </a:ext>
            </a:extLst>
          </p:cNvPr>
          <p:cNvSpPr txBox="1"/>
          <p:nvPr/>
        </p:nvSpPr>
        <p:spPr>
          <a:xfrm>
            <a:off x="5238820" y="6583252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err="1"/>
              <a:t>CaSki</a:t>
            </a:r>
            <a:endParaRPr lang="en-US" sz="10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FB62884-AF70-4D6E-BAB4-B7009B4C3C60}"/>
              </a:ext>
            </a:extLst>
          </p:cNvPr>
          <p:cNvSpPr txBox="1"/>
          <p:nvPr/>
        </p:nvSpPr>
        <p:spPr>
          <a:xfrm>
            <a:off x="1762155" y="659442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C33a</a:t>
            </a:r>
            <a:endParaRPr lang="en-US" sz="8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9EFF0AD-FEAD-4F40-B704-1C59817B0E45}"/>
              </a:ext>
            </a:extLst>
          </p:cNvPr>
          <p:cNvSpPr txBox="1"/>
          <p:nvPr/>
        </p:nvSpPr>
        <p:spPr>
          <a:xfrm>
            <a:off x="-35793" y="382403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F383EFD-8AF4-4BCE-886F-44E7A1817ECC}"/>
              </a:ext>
            </a:extLst>
          </p:cNvPr>
          <p:cNvSpPr txBox="1"/>
          <p:nvPr/>
        </p:nvSpPr>
        <p:spPr>
          <a:xfrm>
            <a:off x="3484704" y="3839423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34D3513-E3E1-43D0-B4E2-E3FE937709EB}"/>
              </a:ext>
            </a:extLst>
          </p:cNvPr>
          <p:cNvSpPr txBox="1"/>
          <p:nvPr/>
        </p:nvSpPr>
        <p:spPr>
          <a:xfrm>
            <a:off x="72075" y="6611508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A4D9E4-2F35-4454-B714-E80B178D6074}"/>
              </a:ext>
            </a:extLst>
          </p:cNvPr>
          <p:cNvSpPr txBox="1"/>
          <p:nvPr/>
        </p:nvSpPr>
        <p:spPr>
          <a:xfrm>
            <a:off x="4173000" y="5872185"/>
            <a:ext cx="2568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D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81B45433-1E91-0D39-3974-D2503AE82DDB}"/>
              </a:ext>
            </a:extLst>
          </p:cNvPr>
          <p:cNvGrpSpPr/>
          <p:nvPr/>
        </p:nvGrpSpPr>
        <p:grpSpPr>
          <a:xfrm>
            <a:off x="109454" y="3831729"/>
            <a:ext cx="3265461" cy="2463549"/>
            <a:chOff x="-2723259" y="2554533"/>
            <a:chExt cx="3265461" cy="246354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E152BBD3-C09C-4323-AC72-3BF505DC99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893" t="1" r="85132" b="66553"/>
            <a:stretch/>
          </p:blipFill>
          <p:spPr>
            <a:xfrm>
              <a:off x="-2723259" y="2554533"/>
              <a:ext cx="942084" cy="2311149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5812FD0-944F-79C9-9401-8A37954346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880" r="50741" b="64390"/>
            <a:stretch/>
          </p:blipFill>
          <p:spPr>
            <a:xfrm>
              <a:off x="-1910120" y="2557449"/>
              <a:ext cx="2452322" cy="2460633"/>
            </a:xfrm>
            <a:prstGeom prst="rect">
              <a:avLst/>
            </a:prstGeom>
          </p:spPr>
        </p:pic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B32737BD-330E-1229-BE41-BB575BE16D5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1051" t="-1" r="1" b="65386"/>
          <a:stretch/>
        </p:blipFill>
        <p:spPr>
          <a:xfrm>
            <a:off x="3601268" y="3884629"/>
            <a:ext cx="3256732" cy="2360664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FDD71EA-D1F4-B2F2-5875-42D19C29E19C}"/>
              </a:ext>
            </a:extLst>
          </p:cNvPr>
          <p:cNvSpPr txBox="1"/>
          <p:nvPr/>
        </p:nvSpPr>
        <p:spPr>
          <a:xfrm>
            <a:off x="3506002" y="6678138"/>
            <a:ext cx="2728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E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F5524192-0D2D-B12F-ABB5-D11DD92496D9}"/>
              </a:ext>
            </a:extLst>
          </p:cNvPr>
          <p:cNvGrpSpPr/>
          <p:nvPr/>
        </p:nvGrpSpPr>
        <p:grpSpPr>
          <a:xfrm>
            <a:off x="2784534" y="6364742"/>
            <a:ext cx="864220" cy="479170"/>
            <a:chOff x="3705585" y="6618006"/>
            <a:chExt cx="864220" cy="479170"/>
          </a:xfrm>
        </p:grpSpPr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00DD3845-9398-D899-F107-FA67641206E1}"/>
                </a:ext>
              </a:extLst>
            </p:cNvPr>
            <p:cNvSpPr/>
            <p:nvPr/>
          </p:nvSpPr>
          <p:spPr>
            <a:xfrm>
              <a:off x="3708425" y="6943745"/>
              <a:ext cx="232455" cy="83642"/>
            </a:xfrm>
            <a:prstGeom prst="rect">
              <a:avLst/>
            </a:prstGeom>
            <a:solidFill>
              <a:srgbClr val="00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b="1"/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94900475-8DB2-A964-56BF-7CB6FA51D0B5}"/>
                </a:ext>
              </a:extLst>
            </p:cNvPr>
            <p:cNvSpPr/>
            <p:nvPr/>
          </p:nvSpPr>
          <p:spPr>
            <a:xfrm>
              <a:off x="3708425" y="6821319"/>
              <a:ext cx="232455" cy="83642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b="1"/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1B5121D3-6DBD-2DB5-4587-1A37C1C34989}"/>
                </a:ext>
              </a:extLst>
            </p:cNvPr>
            <p:cNvSpPr/>
            <p:nvPr/>
          </p:nvSpPr>
          <p:spPr>
            <a:xfrm>
              <a:off x="3705585" y="6702438"/>
              <a:ext cx="232455" cy="83642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b="1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7E8DC5A-061F-4D70-5A94-0F916B1F4156}"/>
                </a:ext>
              </a:extLst>
            </p:cNvPr>
            <p:cNvSpPr txBox="1"/>
            <p:nvPr/>
          </p:nvSpPr>
          <p:spPr>
            <a:xfrm>
              <a:off x="3885688" y="6618006"/>
              <a:ext cx="46674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DMSO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57CCFDE-9DE1-246C-B3B1-B47D48492263}"/>
                </a:ext>
              </a:extLst>
            </p:cNvPr>
            <p:cNvSpPr txBox="1"/>
            <p:nvPr/>
          </p:nvSpPr>
          <p:spPr>
            <a:xfrm>
              <a:off x="3885688" y="6761484"/>
              <a:ext cx="684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24 hours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EE9819B-36F0-007C-F4D6-69FAB1263DB8}"/>
                </a:ext>
              </a:extLst>
            </p:cNvPr>
            <p:cNvSpPr txBox="1"/>
            <p:nvPr/>
          </p:nvSpPr>
          <p:spPr>
            <a:xfrm>
              <a:off x="3885688" y="6881732"/>
              <a:ext cx="6841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48 hours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C2BF7E9-E61D-EFAC-0AA0-EF86DA53E24E}"/>
              </a:ext>
            </a:extLst>
          </p:cNvPr>
          <p:cNvSpPr txBox="1"/>
          <p:nvPr/>
        </p:nvSpPr>
        <p:spPr>
          <a:xfrm>
            <a:off x="0" y="116692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572D7E13-95F8-1585-5D06-D1436C245B77}"/>
              </a:ext>
            </a:extLst>
          </p:cNvPr>
          <p:cNvGrpSpPr/>
          <p:nvPr/>
        </p:nvGrpSpPr>
        <p:grpSpPr>
          <a:xfrm>
            <a:off x="306216" y="1494412"/>
            <a:ext cx="467030" cy="1317629"/>
            <a:chOff x="2150841" y="7968871"/>
            <a:chExt cx="467030" cy="1317629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1AFFB5F-4D3C-505D-76F6-B9279BA5C8C9}"/>
                </a:ext>
              </a:extLst>
            </p:cNvPr>
            <p:cNvSpPr txBox="1"/>
            <p:nvPr/>
          </p:nvSpPr>
          <p:spPr>
            <a:xfrm rot="16200000">
              <a:off x="1860216" y="8259496"/>
              <a:ext cx="8274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/>
                <a:t>Viability (%)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820BE1A-CE5B-5177-9C27-7287F216DC9F}"/>
                </a:ext>
              </a:extLst>
            </p:cNvPr>
            <p:cNvSpPr txBox="1"/>
            <p:nvPr/>
          </p:nvSpPr>
          <p:spPr>
            <a:xfrm>
              <a:off x="2381909" y="9071056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/>
                <a:t>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C58AC7C-E8FC-00BD-C84A-68C32FB54B1A}"/>
                </a:ext>
              </a:extLst>
            </p:cNvPr>
            <p:cNvSpPr txBox="1"/>
            <p:nvPr/>
          </p:nvSpPr>
          <p:spPr>
            <a:xfrm>
              <a:off x="2328383" y="8629424"/>
              <a:ext cx="2872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/>
                <a:t>5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B0BE5FF-CE1D-F33F-862D-819AF001DDB9}"/>
                </a:ext>
              </a:extLst>
            </p:cNvPr>
            <p:cNvSpPr txBox="1"/>
            <p:nvPr/>
          </p:nvSpPr>
          <p:spPr>
            <a:xfrm>
              <a:off x="2263701" y="8175804"/>
              <a:ext cx="3385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/>
                <a:t>100</a:t>
              </a:r>
            </a:p>
          </p:txBody>
        </p:sp>
      </p:grpSp>
      <p:pic>
        <p:nvPicPr>
          <p:cNvPr id="37" name="Picture 36">
            <a:extLst>
              <a:ext uri="{FF2B5EF4-FFF2-40B4-BE49-F238E27FC236}">
                <a16:creationId xmlns:a16="http://schemas.microsoft.com/office/drawing/2014/main" id="{CD5371F7-3DBD-AD97-9700-BF6C5E11F3F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2698" t="15924" r="48311" b="48948"/>
          <a:stretch/>
        </p:blipFill>
        <p:spPr>
          <a:xfrm>
            <a:off x="1181122" y="1299375"/>
            <a:ext cx="238892" cy="614900"/>
          </a:xfrm>
          <a:prstGeom prst="rect">
            <a:avLst/>
          </a:prstGeom>
        </p:spPr>
      </p:pic>
      <p:grpSp>
        <p:nvGrpSpPr>
          <p:cNvPr id="39" name="Group 38">
            <a:extLst>
              <a:ext uri="{FF2B5EF4-FFF2-40B4-BE49-F238E27FC236}">
                <a16:creationId xmlns:a16="http://schemas.microsoft.com/office/drawing/2014/main" id="{7AAD6003-A818-B45D-7FFB-77348215B912}"/>
              </a:ext>
            </a:extLst>
          </p:cNvPr>
          <p:cNvGrpSpPr/>
          <p:nvPr/>
        </p:nvGrpSpPr>
        <p:grpSpPr>
          <a:xfrm>
            <a:off x="691760" y="1166924"/>
            <a:ext cx="1824204" cy="1555166"/>
            <a:chOff x="4848782" y="2120503"/>
            <a:chExt cx="1329488" cy="1188823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4A242445-5604-1FCF-08A1-2B3BF044D76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55563" r="26326"/>
            <a:stretch/>
          </p:blipFill>
          <p:spPr>
            <a:xfrm>
              <a:off x="4848783" y="2781056"/>
              <a:ext cx="1329487" cy="528270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77375DE6-B793-A307-1B0C-F55C811725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68889"/>
            <a:stretch/>
          </p:blipFill>
          <p:spPr>
            <a:xfrm>
              <a:off x="4848782" y="2120503"/>
              <a:ext cx="561418" cy="1188823"/>
            </a:xfrm>
            <a:prstGeom prst="rect">
              <a:avLst/>
            </a:prstGeom>
          </p:spPr>
        </p:pic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C1EDA770-B72B-2FD1-2DC7-B6F09D534FF1}"/>
              </a:ext>
            </a:extLst>
          </p:cNvPr>
          <p:cNvSpPr txBox="1"/>
          <p:nvPr/>
        </p:nvSpPr>
        <p:spPr>
          <a:xfrm>
            <a:off x="627387" y="26916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/>
              <a:t>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B7536DF-1088-9C1B-EC76-00A09DF44AF1}"/>
              </a:ext>
            </a:extLst>
          </p:cNvPr>
          <p:cNvSpPr txBox="1"/>
          <p:nvPr/>
        </p:nvSpPr>
        <p:spPr>
          <a:xfrm>
            <a:off x="2301276" y="2691613"/>
            <a:ext cx="23596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/>
              <a:t>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3D7F391-C9D9-74AF-55B5-D9158EBB60D3}"/>
              </a:ext>
            </a:extLst>
          </p:cNvPr>
          <p:cNvSpPr txBox="1"/>
          <p:nvPr/>
        </p:nvSpPr>
        <p:spPr>
          <a:xfrm>
            <a:off x="1464333" y="26916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/>
              <a:t>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8C0C829-0E1F-6BFE-C3B0-D0C667907C62}"/>
              </a:ext>
            </a:extLst>
          </p:cNvPr>
          <p:cNvSpPr txBox="1"/>
          <p:nvPr/>
        </p:nvSpPr>
        <p:spPr>
          <a:xfrm>
            <a:off x="1111580" y="2770760"/>
            <a:ext cx="9845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AOH1996 (</a:t>
            </a:r>
            <a:r>
              <a:rPr lang="el-GR" sz="1000" b="1" dirty="0"/>
              <a:t>μ</a:t>
            </a:r>
            <a:r>
              <a:rPr lang="en-US" sz="1000" b="1" dirty="0"/>
              <a:t>M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7784783-4890-F51D-DF72-8BA95CBD6FFE}"/>
              </a:ext>
            </a:extLst>
          </p:cNvPr>
          <p:cNvSpPr txBox="1"/>
          <p:nvPr/>
        </p:nvSpPr>
        <p:spPr>
          <a:xfrm>
            <a:off x="1305321" y="1357779"/>
            <a:ext cx="394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HFK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780D38A-4636-2CEE-9470-84C0E57E3778}"/>
              </a:ext>
            </a:extLst>
          </p:cNvPr>
          <p:cNvSpPr txBox="1"/>
          <p:nvPr/>
        </p:nvSpPr>
        <p:spPr>
          <a:xfrm>
            <a:off x="1300906" y="1557804"/>
            <a:ext cx="6511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/>
              <a:t>HFK-</a:t>
            </a:r>
            <a:r>
              <a:rPr lang="en-US" sz="1000" b="1" dirty="0" err="1"/>
              <a:t>Tert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40704919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6637B4-2A10-C83C-2390-C63C847BB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gen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45869B9-D278-6FEE-AF88-42F4C27CC55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1800" b="1" i="1" u="sng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Fig</a:t>
            </a:r>
            <a:r>
              <a:rPr lang="en-US" sz="1800" b="1" i="1" u="sng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1: AOH1996 induces G2/M arrest followed by apoptosis in cervical cancer cells.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se-response curves for AOH1996 in primary HFKs and TERT-immortalized HFKs (HFK-TERT) reveal comparable sensitivity, validating the use of HFK-TERT in live-cell imaging experiments. Flow cytometric analysis of DNA content was performed in DMSO-treated and AOH1996-treated cells at 24 and 48 hours to evaluate cell cycle distribution. Cells were stained with propidium iodide and categorized into sub-G1 (apoptotic), G1, S, and G2/M populations.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800" b="1" i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FKs exhibit a robust G2/M arrest at 24h, with a corresponding decrease in G1 population and no significant increase in sub-G1, suggesting a non-lethal cytostatic arrest.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eLa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C33a </a:t>
            </a:r>
            <a:r>
              <a:rPr lang="en-US" sz="1800" b="1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E)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en-US" sz="1800" i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Ski cell 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es also arrest in G2/M at 24h but show significant accumulation in sub-G1 and &gt;G2/M populations by 48h, indicating induction of apoptosis and potential polyploidy following failed </a:t>
            </a:r>
            <a:r>
              <a:rPr lang="en-US" sz="1800" i="1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itosis.Data</a:t>
            </a:r>
            <a:r>
              <a:rPr lang="en-US" sz="1800" i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present mean ± SEM from at least three biological replicates. Statistical comparisons were made against DMSO controls for each phase using two-way ANOVA *p&lt;0.05, **p&lt;0.01,***p&lt;0.001 ****p&lt;0.0001.</a:t>
            </a:r>
            <a:endParaRPr lang="en-US" sz="1800" i="1" dirty="0">
              <a:solidFill>
                <a:srgbClr val="44546A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27951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255</Words>
  <Application>Microsoft Office PowerPoint</Application>
  <PresentationFormat>Widescreen</PresentationFormat>
  <Paragraphs>2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 Theme</vt:lpstr>
      <vt:lpstr>Supplemental Figure 1:</vt:lpstr>
      <vt:lpstr>Legend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icholas Wallace</dc:creator>
  <cp:lastModifiedBy>Nicholas Wallace</cp:lastModifiedBy>
  <cp:revision>8</cp:revision>
  <dcterms:created xsi:type="dcterms:W3CDTF">2026-03-31T21:32:41Z</dcterms:created>
  <dcterms:modified xsi:type="dcterms:W3CDTF">2026-04-03T16:01:01Z</dcterms:modified>
</cp:coreProperties>
</file>